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65" r:id="rId3"/>
    <p:sldId id="257" r:id="rId4"/>
    <p:sldId id="258" r:id="rId5"/>
    <p:sldId id="270" r:id="rId6"/>
    <p:sldId id="271" r:id="rId7"/>
    <p:sldId id="272" r:id="rId8"/>
    <p:sldId id="260" r:id="rId9"/>
    <p:sldId id="262" r:id="rId10"/>
    <p:sldId id="268" r:id="rId11"/>
    <p:sldId id="269" r:id="rId12"/>
  </p:sldIdLst>
  <p:sldSz cx="6335713" cy="36179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40" userDrawn="1">
          <p15:clr>
            <a:srgbClr val="A4A3A4"/>
          </p15:clr>
        </p15:guide>
        <p15:guide id="2" pos="19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45" d="100"/>
          <a:sy n="145" d="100"/>
        </p:scale>
        <p:origin x="633" y="63"/>
      </p:cViewPr>
      <p:guideLst>
        <p:guide orient="horz" pos="1140"/>
        <p:guide pos="19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91964" y="592098"/>
            <a:ext cx="4751785" cy="1259570"/>
          </a:xfrm>
        </p:spPr>
        <p:txBody>
          <a:bodyPr anchor="b"/>
          <a:lstStyle>
            <a:lvl1pPr algn="ctr">
              <a:defRPr sz="3118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91964" y="1900242"/>
            <a:ext cx="4751785" cy="873491"/>
          </a:xfrm>
        </p:spPr>
        <p:txBody>
          <a:bodyPr/>
          <a:lstStyle>
            <a:lvl1pPr marL="0" indent="0" algn="ctr">
              <a:buNone/>
              <a:defRPr sz="1247"/>
            </a:lvl1pPr>
            <a:lvl2pPr marL="237607" indent="0" algn="ctr">
              <a:buNone/>
              <a:defRPr sz="1039"/>
            </a:lvl2pPr>
            <a:lvl3pPr marL="475214" indent="0" algn="ctr">
              <a:buNone/>
              <a:defRPr sz="935"/>
            </a:lvl3pPr>
            <a:lvl4pPr marL="712821" indent="0" algn="ctr">
              <a:buNone/>
              <a:defRPr sz="832"/>
            </a:lvl4pPr>
            <a:lvl5pPr marL="950427" indent="0" algn="ctr">
              <a:buNone/>
              <a:defRPr sz="832"/>
            </a:lvl5pPr>
            <a:lvl6pPr marL="1188034" indent="0" algn="ctr">
              <a:buNone/>
              <a:defRPr sz="832"/>
            </a:lvl6pPr>
            <a:lvl7pPr marL="1425641" indent="0" algn="ctr">
              <a:buNone/>
              <a:defRPr sz="832"/>
            </a:lvl7pPr>
            <a:lvl8pPr marL="1663248" indent="0" algn="ctr">
              <a:buNone/>
              <a:defRPr sz="832"/>
            </a:lvl8pPr>
            <a:lvl9pPr marL="1900855" indent="0" algn="ctr">
              <a:buNone/>
              <a:defRPr sz="832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5791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508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33995" y="192620"/>
            <a:ext cx="1366138" cy="306601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5580" y="192620"/>
            <a:ext cx="4019218" cy="3066014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06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979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2281" y="901966"/>
            <a:ext cx="5464552" cy="1504951"/>
          </a:xfrm>
        </p:spPr>
        <p:txBody>
          <a:bodyPr anchor="b"/>
          <a:lstStyle>
            <a:lvl1pPr>
              <a:defRPr sz="3118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2281" y="2421155"/>
            <a:ext cx="5464552" cy="791418"/>
          </a:xfrm>
        </p:spPr>
        <p:txBody>
          <a:bodyPr/>
          <a:lstStyle>
            <a:lvl1pPr marL="0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1pPr>
            <a:lvl2pPr marL="23760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2pPr>
            <a:lvl3pPr marL="475214" indent="0">
              <a:buNone/>
              <a:defRPr sz="935">
                <a:solidFill>
                  <a:schemeClr val="tx1">
                    <a:tint val="75000"/>
                  </a:schemeClr>
                </a:solidFill>
              </a:defRPr>
            </a:lvl3pPr>
            <a:lvl4pPr marL="712821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4pPr>
            <a:lvl5pPr marL="950427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5pPr>
            <a:lvl6pPr marL="1188034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6pPr>
            <a:lvl7pPr marL="1425641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7pPr>
            <a:lvl8pPr marL="1663248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8pPr>
            <a:lvl9pPr marL="1900855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990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5580" y="963102"/>
            <a:ext cx="2692678" cy="229553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7455" y="963102"/>
            <a:ext cx="2692678" cy="229553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986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192621"/>
            <a:ext cx="5464552" cy="69929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406" y="886891"/>
            <a:ext cx="2680303" cy="434652"/>
          </a:xfrm>
        </p:spPr>
        <p:txBody>
          <a:bodyPr anchor="b"/>
          <a:lstStyle>
            <a:lvl1pPr marL="0" indent="0">
              <a:buNone/>
              <a:defRPr sz="1247" b="1"/>
            </a:lvl1pPr>
            <a:lvl2pPr marL="237607" indent="0">
              <a:buNone/>
              <a:defRPr sz="1039" b="1"/>
            </a:lvl2pPr>
            <a:lvl3pPr marL="475214" indent="0">
              <a:buNone/>
              <a:defRPr sz="935" b="1"/>
            </a:lvl3pPr>
            <a:lvl4pPr marL="712821" indent="0">
              <a:buNone/>
              <a:defRPr sz="832" b="1"/>
            </a:lvl4pPr>
            <a:lvl5pPr marL="950427" indent="0">
              <a:buNone/>
              <a:defRPr sz="832" b="1"/>
            </a:lvl5pPr>
            <a:lvl6pPr marL="1188034" indent="0">
              <a:buNone/>
              <a:defRPr sz="832" b="1"/>
            </a:lvl6pPr>
            <a:lvl7pPr marL="1425641" indent="0">
              <a:buNone/>
              <a:defRPr sz="832" b="1"/>
            </a:lvl7pPr>
            <a:lvl8pPr marL="1663248" indent="0">
              <a:buNone/>
              <a:defRPr sz="832" b="1"/>
            </a:lvl8pPr>
            <a:lvl9pPr marL="1900855" indent="0">
              <a:buNone/>
              <a:defRPr sz="832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6406" y="1321543"/>
            <a:ext cx="2680303" cy="1943791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07455" y="886891"/>
            <a:ext cx="2693503" cy="434652"/>
          </a:xfrm>
        </p:spPr>
        <p:txBody>
          <a:bodyPr anchor="b"/>
          <a:lstStyle>
            <a:lvl1pPr marL="0" indent="0">
              <a:buNone/>
              <a:defRPr sz="1247" b="1"/>
            </a:lvl1pPr>
            <a:lvl2pPr marL="237607" indent="0">
              <a:buNone/>
              <a:defRPr sz="1039" b="1"/>
            </a:lvl2pPr>
            <a:lvl3pPr marL="475214" indent="0">
              <a:buNone/>
              <a:defRPr sz="935" b="1"/>
            </a:lvl3pPr>
            <a:lvl4pPr marL="712821" indent="0">
              <a:buNone/>
              <a:defRPr sz="832" b="1"/>
            </a:lvl4pPr>
            <a:lvl5pPr marL="950427" indent="0">
              <a:buNone/>
              <a:defRPr sz="832" b="1"/>
            </a:lvl5pPr>
            <a:lvl6pPr marL="1188034" indent="0">
              <a:buNone/>
              <a:defRPr sz="832" b="1"/>
            </a:lvl6pPr>
            <a:lvl7pPr marL="1425641" indent="0">
              <a:buNone/>
              <a:defRPr sz="832" b="1"/>
            </a:lvl7pPr>
            <a:lvl8pPr marL="1663248" indent="0">
              <a:buNone/>
              <a:defRPr sz="832" b="1"/>
            </a:lvl8pPr>
            <a:lvl9pPr marL="1900855" indent="0">
              <a:buNone/>
              <a:defRPr sz="832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07455" y="1321543"/>
            <a:ext cx="2693503" cy="1943791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496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6166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718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241194"/>
            <a:ext cx="2043432" cy="844180"/>
          </a:xfrm>
        </p:spPr>
        <p:txBody>
          <a:bodyPr anchor="b"/>
          <a:lstStyle>
            <a:lvl1pPr>
              <a:defRPr sz="166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93503" y="520913"/>
            <a:ext cx="3207455" cy="2571063"/>
          </a:xfrm>
        </p:spPr>
        <p:txBody>
          <a:bodyPr/>
          <a:lstStyle>
            <a:lvl1pPr>
              <a:defRPr sz="1663"/>
            </a:lvl1pPr>
            <a:lvl2pPr>
              <a:defRPr sz="1455"/>
            </a:lvl2pPr>
            <a:lvl3pPr>
              <a:defRPr sz="1247"/>
            </a:lvl3pPr>
            <a:lvl4pPr>
              <a:defRPr sz="1039"/>
            </a:lvl4pPr>
            <a:lvl5pPr>
              <a:defRPr sz="1039"/>
            </a:lvl5pPr>
            <a:lvl6pPr>
              <a:defRPr sz="1039"/>
            </a:lvl6pPr>
            <a:lvl7pPr>
              <a:defRPr sz="1039"/>
            </a:lvl7pPr>
            <a:lvl8pPr>
              <a:defRPr sz="1039"/>
            </a:lvl8pPr>
            <a:lvl9pPr>
              <a:defRPr sz="1039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1085374"/>
            <a:ext cx="2043432" cy="2010789"/>
          </a:xfrm>
        </p:spPr>
        <p:txBody>
          <a:bodyPr/>
          <a:lstStyle>
            <a:lvl1pPr marL="0" indent="0">
              <a:buNone/>
              <a:defRPr sz="832"/>
            </a:lvl1pPr>
            <a:lvl2pPr marL="237607" indent="0">
              <a:buNone/>
              <a:defRPr sz="728"/>
            </a:lvl2pPr>
            <a:lvl3pPr marL="475214" indent="0">
              <a:buNone/>
              <a:defRPr sz="624"/>
            </a:lvl3pPr>
            <a:lvl4pPr marL="712821" indent="0">
              <a:buNone/>
              <a:defRPr sz="520"/>
            </a:lvl4pPr>
            <a:lvl5pPr marL="950427" indent="0">
              <a:buNone/>
              <a:defRPr sz="520"/>
            </a:lvl5pPr>
            <a:lvl6pPr marL="1188034" indent="0">
              <a:buNone/>
              <a:defRPr sz="520"/>
            </a:lvl6pPr>
            <a:lvl7pPr marL="1425641" indent="0">
              <a:buNone/>
              <a:defRPr sz="520"/>
            </a:lvl7pPr>
            <a:lvl8pPr marL="1663248" indent="0">
              <a:buNone/>
              <a:defRPr sz="520"/>
            </a:lvl8pPr>
            <a:lvl9pPr marL="1900855" indent="0">
              <a:buNone/>
              <a:defRPr sz="52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985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241194"/>
            <a:ext cx="2043432" cy="844180"/>
          </a:xfrm>
        </p:spPr>
        <p:txBody>
          <a:bodyPr anchor="b"/>
          <a:lstStyle>
            <a:lvl1pPr>
              <a:defRPr sz="166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93503" y="520913"/>
            <a:ext cx="3207455" cy="2571063"/>
          </a:xfrm>
        </p:spPr>
        <p:txBody>
          <a:bodyPr anchor="t"/>
          <a:lstStyle>
            <a:lvl1pPr marL="0" indent="0">
              <a:buNone/>
              <a:defRPr sz="1663"/>
            </a:lvl1pPr>
            <a:lvl2pPr marL="237607" indent="0">
              <a:buNone/>
              <a:defRPr sz="1455"/>
            </a:lvl2pPr>
            <a:lvl3pPr marL="475214" indent="0">
              <a:buNone/>
              <a:defRPr sz="1247"/>
            </a:lvl3pPr>
            <a:lvl4pPr marL="712821" indent="0">
              <a:buNone/>
              <a:defRPr sz="1039"/>
            </a:lvl4pPr>
            <a:lvl5pPr marL="950427" indent="0">
              <a:buNone/>
              <a:defRPr sz="1039"/>
            </a:lvl5pPr>
            <a:lvl6pPr marL="1188034" indent="0">
              <a:buNone/>
              <a:defRPr sz="1039"/>
            </a:lvl6pPr>
            <a:lvl7pPr marL="1425641" indent="0">
              <a:buNone/>
              <a:defRPr sz="1039"/>
            </a:lvl7pPr>
            <a:lvl8pPr marL="1663248" indent="0">
              <a:buNone/>
              <a:defRPr sz="1039"/>
            </a:lvl8pPr>
            <a:lvl9pPr marL="1900855" indent="0">
              <a:buNone/>
              <a:defRPr sz="1039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1085374"/>
            <a:ext cx="2043432" cy="2010789"/>
          </a:xfrm>
        </p:spPr>
        <p:txBody>
          <a:bodyPr/>
          <a:lstStyle>
            <a:lvl1pPr marL="0" indent="0">
              <a:buNone/>
              <a:defRPr sz="832"/>
            </a:lvl1pPr>
            <a:lvl2pPr marL="237607" indent="0">
              <a:buNone/>
              <a:defRPr sz="728"/>
            </a:lvl2pPr>
            <a:lvl3pPr marL="475214" indent="0">
              <a:buNone/>
              <a:defRPr sz="624"/>
            </a:lvl3pPr>
            <a:lvl4pPr marL="712821" indent="0">
              <a:buNone/>
              <a:defRPr sz="520"/>
            </a:lvl4pPr>
            <a:lvl5pPr marL="950427" indent="0">
              <a:buNone/>
              <a:defRPr sz="520"/>
            </a:lvl5pPr>
            <a:lvl6pPr marL="1188034" indent="0">
              <a:buNone/>
              <a:defRPr sz="520"/>
            </a:lvl6pPr>
            <a:lvl7pPr marL="1425641" indent="0">
              <a:buNone/>
              <a:defRPr sz="520"/>
            </a:lvl7pPr>
            <a:lvl8pPr marL="1663248" indent="0">
              <a:buNone/>
              <a:defRPr sz="520"/>
            </a:lvl8pPr>
            <a:lvl9pPr marL="1900855" indent="0">
              <a:buNone/>
              <a:defRPr sz="52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063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5581" y="192621"/>
            <a:ext cx="5464552" cy="69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5581" y="963102"/>
            <a:ext cx="5464552" cy="22955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5580" y="3353270"/>
            <a:ext cx="1425535" cy="1926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1BFEB5-5FF4-4E0F-8997-2057788D2F2E}" type="datetimeFigureOut">
              <a:rPr lang="zh-CN" altLang="en-US" smtClean="0"/>
              <a:t>2024/3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8705" y="3353270"/>
            <a:ext cx="2138303" cy="1926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74598" y="3353270"/>
            <a:ext cx="1425535" cy="1926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1FE95-032D-4579-AF1F-59A8AD8500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4270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75214" rtl="0" eaLnBrk="1" latinLnBrk="0" hangingPunct="1">
        <a:lnSpc>
          <a:spcPct val="90000"/>
        </a:lnSpc>
        <a:spcBef>
          <a:spcPct val="0"/>
        </a:spcBef>
        <a:buNone/>
        <a:defRPr sz="22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8803" indent="-118803" algn="l" defTabSz="475214" rtl="0" eaLnBrk="1" latinLnBrk="0" hangingPunct="1">
        <a:lnSpc>
          <a:spcPct val="90000"/>
        </a:lnSpc>
        <a:spcBef>
          <a:spcPts val="520"/>
        </a:spcBef>
        <a:buFont typeface="Arial" panose="020B0604020202020204" pitchFamily="34" charset="0"/>
        <a:buChar char="•"/>
        <a:defRPr sz="1455" kern="1200">
          <a:solidFill>
            <a:schemeClr val="tx1"/>
          </a:solidFill>
          <a:latin typeface="+mn-lt"/>
          <a:ea typeface="+mn-ea"/>
          <a:cs typeface="+mn-cs"/>
        </a:defRPr>
      </a:lvl1pPr>
      <a:lvl2pPr marL="356410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2pPr>
      <a:lvl3pPr marL="594017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3pPr>
      <a:lvl4pPr marL="831624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1069231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306838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544444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782051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2019658" indent="-118803" algn="l" defTabSz="475214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1pPr>
      <a:lvl2pPr marL="237607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2pPr>
      <a:lvl3pPr marL="475214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712821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950427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188034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425641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663248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1900855" algn="l" defTabSz="475214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10" Type="http://schemas.openxmlformats.org/officeDocument/2006/relationships/image" Target="../media/image67.png"/><Relationship Id="rId4" Type="http://schemas.openxmlformats.org/officeDocument/2006/relationships/image" Target="../media/image61.png"/><Relationship Id="rId9" Type="http://schemas.openxmlformats.org/officeDocument/2006/relationships/image" Target="../media/image66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3" Type="http://schemas.openxmlformats.org/officeDocument/2006/relationships/image" Target="../media/image69.png"/><Relationship Id="rId7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10" Type="http://schemas.openxmlformats.org/officeDocument/2006/relationships/image" Target="../media/image76.png"/><Relationship Id="rId4" Type="http://schemas.openxmlformats.org/officeDocument/2006/relationships/image" Target="../media/image70.png"/><Relationship Id="rId9" Type="http://schemas.openxmlformats.org/officeDocument/2006/relationships/image" Target="../media/image7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321614" y="814587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11166" y="121847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36752" y="2579621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51193" y="289431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0593" y="44675"/>
            <a:ext cx="0" cy="3526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1200614" y="192997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1978098" y="-14717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592" y="725126"/>
            <a:ext cx="2526754" cy="360000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 rot="18099302">
            <a:off x="2715596" y="195123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p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 rot="18398896">
            <a:off x="1055237" y="361458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8282182">
            <a:off x="1477148" y="368259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 rot="18196533">
            <a:off x="2355714" y="310574"/>
            <a:ext cx="760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1072721" y="2030619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743437" y="1855740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 rot="18099302">
            <a:off x="2591861" y="2011005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p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8398896">
            <a:off x="980176" y="2028436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 rot="18282182">
            <a:off x="1270515" y="2167354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 rot="18196533">
            <a:off x="2099160" y="1982971"/>
            <a:ext cx="1017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 flipV="1">
            <a:off x="3797160" y="154490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4574644" y="-5322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 rot="18099302">
            <a:off x="5212351" y="135399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5p </a:t>
            </a:r>
            <a:endParaRPr lang="en-US" altLang="zh-CN" sz="5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 rot="18398896">
            <a:off x="3709308" y="196593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8282182">
            <a:off x="4003903" y="287076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 rot="18196533">
            <a:off x="4734488" y="135398"/>
            <a:ext cx="1060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4" name="图片 5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0233" y="1109977"/>
            <a:ext cx="2519490" cy="3600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8086" y="627650"/>
            <a:ext cx="2520000" cy="359586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7043" y="1011752"/>
            <a:ext cx="2527541" cy="364426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9917" y="2497882"/>
            <a:ext cx="2520000" cy="364085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9917" y="2877256"/>
            <a:ext cx="2520000" cy="371407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0233" y="1481397"/>
            <a:ext cx="2520000" cy="398869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78086" y="1400694"/>
            <a:ext cx="2520000" cy="331151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19917" y="3257888"/>
            <a:ext cx="2520000" cy="320278"/>
          </a:xfrm>
          <a:prstGeom prst="rect">
            <a:avLst/>
          </a:prstGeom>
        </p:spPr>
      </p:pic>
      <p:sp>
        <p:nvSpPr>
          <p:cNvPr id="63" name="文本框 62"/>
          <p:cNvSpPr txBox="1"/>
          <p:nvPr/>
        </p:nvSpPr>
        <p:spPr>
          <a:xfrm>
            <a:off x="295876" y="1557144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336752" y="3285058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840233" y="697377"/>
            <a:ext cx="2549118" cy="121907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1116399" y="43066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2H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28590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44640" y="861601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59155" y="1202707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59155" y="2684654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37071" y="2965834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0593" y="44675"/>
            <a:ext cx="0" cy="3526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1085057" y="2067620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851685" y="1868318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 flipV="1">
            <a:off x="1120321" y="141837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1749703" y="-50585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 rot="18300000">
            <a:off x="2559313" y="242330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 rot="18300000">
            <a:off x="933030" y="420843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 rot="18300000">
            <a:off x="2079602" y="342468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 rot="18300000">
            <a:off x="1288293" y="306320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接连接符 63"/>
          <p:cNvCxnSpPr/>
          <p:nvPr/>
        </p:nvCxnSpPr>
        <p:spPr>
          <a:xfrm flipV="1">
            <a:off x="4030423" y="149726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>
            <a:off x="4660158" y="-19810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281238" y="1557380"/>
            <a:ext cx="526329" cy="18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281238" y="3301525"/>
            <a:ext cx="526329" cy="18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4" name="图片 7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5801" y="775073"/>
            <a:ext cx="2520000" cy="316743"/>
          </a:xfrm>
          <a:prstGeom prst="rect">
            <a:avLst/>
          </a:prstGeom>
        </p:spPr>
      </p:pic>
      <p:pic>
        <p:nvPicPr>
          <p:cNvPr id="76" name="图片 7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010" y="1457150"/>
            <a:ext cx="2520000" cy="311105"/>
          </a:xfrm>
          <a:prstGeom prst="rect">
            <a:avLst/>
          </a:prstGeom>
        </p:spPr>
      </p:pic>
      <p:pic>
        <p:nvPicPr>
          <p:cNvPr id="78" name="图片 7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8010" y="1114890"/>
            <a:ext cx="2520000" cy="325154"/>
          </a:xfrm>
          <a:prstGeom prst="rect">
            <a:avLst/>
          </a:prstGeom>
        </p:spPr>
      </p:pic>
      <p:pic>
        <p:nvPicPr>
          <p:cNvPr id="79" name="图片 7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3110" y="754775"/>
            <a:ext cx="2520000" cy="310074"/>
          </a:xfrm>
          <a:prstGeom prst="rect">
            <a:avLst/>
          </a:prstGeom>
        </p:spPr>
      </p:pic>
      <p:sp>
        <p:nvSpPr>
          <p:cNvPr id="80" name="文本框 79"/>
          <p:cNvSpPr txBox="1"/>
          <p:nvPr/>
        </p:nvSpPr>
        <p:spPr>
          <a:xfrm rot="18300000">
            <a:off x="5449650" y="246111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 rot="18300000">
            <a:off x="3823367" y="424624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 rot="18300000">
            <a:off x="4178630" y="310101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 rot="18300000">
            <a:off x="2480061" y="2048739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 rot="18300000">
            <a:off x="1037387" y="2200837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 rot="18300000">
            <a:off x="1394797" y="2172224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图片 8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23110" y="1390406"/>
            <a:ext cx="2520000" cy="323210"/>
          </a:xfrm>
          <a:prstGeom prst="rect">
            <a:avLst/>
          </a:prstGeom>
        </p:spPr>
      </p:pic>
      <p:pic>
        <p:nvPicPr>
          <p:cNvPr id="90" name="图片 8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23110" y="1069841"/>
            <a:ext cx="2520000" cy="306934"/>
          </a:xfrm>
          <a:prstGeom prst="rect">
            <a:avLst/>
          </a:prstGeom>
        </p:spPr>
      </p:pic>
      <p:pic>
        <p:nvPicPr>
          <p:cNvPr id="91" name="图片 9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1550" y="2541491"/>
            <a:ext cx="2520000" cy="326983"/>
          </a:xfrm>
          <a:prstGeom prst="rect">
            <a:avLst/>
          </a:prstGeom>
        </p:spPr>
      </p:pic>
      <p:pic>
        <p:nvPicPr>
          <p:cNvPr id="93" name="图片 9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5801" y="3229424"/>
            <a:ext cx="2520000" cy="319396"/>
          </a:xfrm>
          <a:prstGeom prst="rect">
            <a:avLst/>
          </a:prstGeom>
        </p:spPr>
      </p:pic>
      <p:pic>
        <p:nvPicPr>
          <p:cNvPr id="94" name="图片 9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5801" y="2882330"/>
            <a:ext cx="2520000" cy="322569"/>
          </a:xfrm>
          <a:prstGeom prst="rect">
            <a:avLst/>
          </a:prstGeom>
        </p:spPr>
      </p:pic>
      <p:sp>
        <p:nvSpPr>
          <p:cNvPr id="42" name="文本框 41"/>
          <p:cNvSpPr txBox="1"/>
          <p:nvPr/>
        </p:nvSpPr>
        <p:spPr>
          <a:xfrm rot="18300000">
            <a:off x="4928204" y="346351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8300000">
            <a:off x="2014232" y="2158998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672220" y="757793"/>
            <a:ext cx="2582029" cy="103966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1019121" y="-19808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E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37337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47702" y="774470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50797" y="1136101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59155" y="2684654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37073" y="2947897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0593" y="44675"/>
            <a:ext cx="0" cy="3526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1115323" y="1962894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801925" y="1778333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 flipV="1">
            <a:off x="1117599" y="128140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1749703" y="-48843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 rot="18300000">
            <a:off x="2559313" y="242330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 rot="18300000">
            <a:off x="930534" y="404745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 rot="18300000">
            <a:off x="1288293" y="306320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接连接符 63"/>
          <p:cNvCxnSpPr/>
          <p:nvPr/>
        </p:nvCxnSpPr>
        <p:spPr>
          <a:xfrm flipV="1">
            <a:off x="4030776" y="170870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>
            <a:off x="4660158" y="-19810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281240" y="1526666"/>
            <a:ext cx="526329" cy="18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250797" y="3326691"/>
            <a:ext cx="526329" cy="18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 rot="18300000">
            <a:off x="5449650" y="246111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 rot="18300000">
            <a:off x="3823367" y="424624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 rot="18300000">
            <a:off x="4178630" y="310101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 rot="18300000">
            <a:off x="2473641" y="2063388"/>
            <a:ext cx="1017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LV-CS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 rot="18300000">
            <a:off x="847358" y="2241901"/>
            <a:ext cx="7129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tin+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 rot="18300000">
            <a:off x="1202621" y="2127378"/>
            <a:ext cx="1027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图片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8211" y="752203"/>
            <a:ext cx="2520000" cy="320353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368" y="1432946"/>
            <a:ext cx="2520000" cy="321216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8211" y="1088075"/>
            <a:ext cx="2520000" cy="324718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0225" y="719662"/>
            <a:ext cx="2520000" cy="320765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0225" y="1451809"/>
            <a:ext cx="2522091" cy="324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3806" y="1081348"/>
            <a:ext cx="2523963" cy="317019"/>
          </a:xfrm>
          <a:prstGeom prst="rect">
            <a:avLst/>
          </a:prstGeom>
        </p:spPr>
      </p:pic>
      <p:pic>
        <p:nvPicPr>
          <p:cNvPr id="52" name="图片 5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7213" y="2570217"/>
            <a:ext cx="2514359" cy="320466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9770" y="3252146"/>
            <a:ext cx="2520000" cy="330296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1657" y="2902493"/>
            <a:ext cx="2520000" cy="324972"/>
          </a:xfrm>
          <a:prstGeom prst="rect">
            <a:avLst/>
          </a:prstGeom>
        </p:spPr>
      </p:pic>
      <p:sp>
        <p:nvSpPr>
          <p:cNvPr id="45" name="文本框 44"/>
          <p:cNvSpPr txBox="1"/>
          <p:nvPr/>
        </p:nvSpPr>
        <p:spPr>
          <a:xfrm rot="18300000">
            <a:off x="2119470" y="306291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8300000">
            <a:off x="4929883" y="349926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 rot="18300000">
            <a:off x="2049799" y="2142266"/>
            <a:ext cx="860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-5p mimics+Fer-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674500" y="718816"/>
            <a:ext cx="2600651" cy="105699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/>
          <p:cNvSpPr txBox="1"/>
          <p:nvPr/>
        </p:nvSpPr>
        <p:spPr>
          <a:xfrm>
            <a:off x="1047535" y="-33455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E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6529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336752" y="788565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33903" y="114990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18096" y="2540416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24323" y="2922450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SL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300593" y="44675"/>
            <a:ext cx="0" cy="3526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 flipV="1">
            <a:off x="1200614" y="192997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1978098" y="-14717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 rot="18099302">
            <a:off x="2710433" y="182620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p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 rot="18398896">
            <a:off x="1126773" y="146640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8282182">
            <a:off x="1459544" y="321236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 rot="18196533">
            <a:off x="2217932" y="160773"/>
            <a:ext cx="1060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1120321" y="1985124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749703" y="179444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 rot="18099302">
            <a:off x="2717765" y="1975102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5p </a:t>
            </a:r>
            <a:endParaRPr lang="en-US" altLang="zh-CN" sz="5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8398896">
            <a:off x="1076975" y="1944366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 rot="18282182">
            <a:off x="1450139" y="2144360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 rot="18196533">
            <a:off x="2194706" y="1963093"/>
            <a:ext cx="1060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 </a:t>
            </a:r>
            <a:endParaRPr lang="en-US" altLang="zh-CN" sz="5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 flipV="1">
            <a:off x="3797160" y="154490"/>
            <a:ext cx="2224644" cy="2849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4574644" y="-5322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 rot="18099302">
            <a:off x="5350924" y="122449"/>
            <a:ext cx="1024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122 5p </a:t>
            </a:r>
            <a:endParaRPr lang="en-US" altLang="zh-CN" sz="5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 rot="18398896">
            <a:off x="3781961" y="106847"/>
            <a:ext cx="709305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 rot="18282182">
            <a:off x="4036774" y="309776"/>
            <a:ext cx="1021949" cy="172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astin+miR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 rot="18196533">
            <a:off x="4787838" y="123456"/>
            <a:ext cx="1060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astin+miR122-5p 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944" y="1081363"/>
            <a:ext cx="2520000" cy="365064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8549" y="697843"/>
            <a:ext cx="2528096" cy="353165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14762" y="657649"/>
            <a:ext cx="2522314" cy="362287"/>
          </a:xfrm>
          <a:prstGeom prst="rect">
            <a:avLst/>
          </a:prstGeom>
        </p:spPr>
      </p:pic>
      <p:pic>
        <p:nvPicPr>
          <p:cNvPr id="52" name="图片 51"/>
          <p:cNvPicPr>
            <a:picLocks noChangeAspect="1"/>
          </p:cNvPicPr>
          <p:nvPr/>
        </p:nvPicPr>
        <p:blipFill>
          <a:blip r:embed="rId5"/>
          <a:srcRect l="1775" t="20138" r="1233" b="6544"/>
          <a:stretch>
            <a:fillRect/>
          </a:stretch>
        </p:blipFill>
        <p:spPr>
          <a:xfrm>
            <a:off x="3714762" y="1054711"/>
            <a:ext cx="2502051" cy="356991"/>
          </a:xfrm>
          <a:custGeom>
            <a:avLst/>
            <a:gdLst>
              <a:gd name="connsiteX0" fmla="*/ 0 w 2444195"/>
              <a:gd name="connsiteY0" fmla="*/ 0 h 434601"/>
              <a:gd name="connsiteX1" fmla="*/ 2444195 w 2444195"/>
              <a:gd name="connsiteY1" fmla="*/ 0 h 434601"/>
              <a:gd name="connsiteX2" fmla="*/ 2444195 w 2444195"/>
              <a:gd name="connsiteY2" fmla="*/ 434601 h 434601"/>
              <a:gd name="connsiteX3" fmla="*/ 0 w 2444195"/>
              <a:gd name="connsiteY3" fmla="*/ 434601 h 43460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44195" h="434601">
                <a:moveTo>
                  <a:pt x="0" y="0"/>
                </a:moveTo>
                <a:lnTo>
                  <a:pt x="2444195" y="0"/>
                </a:lnTo>
                <a:lnTo>
                  <a:pt x="2444195" y="434601"/>
                </a:lnTo>
                <a:lnTo>
                  <a:pt x="0" y="434601"/>
                </a:lnTo>
                <a:close/>
              </a:path>
            </a:pathLst>
          </a:custGeom>
        </p:spPr>
      </p:pic>
      <p:pic>
        <p:nvPicPr>
          <p:cNvPr id="59" name="图片 5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3134" y="2484845"/>
            <a:ext cx="2522124" cy="277979"/>
          </a:xfrm>
          <a:prstGeom prst="rect">
            <a:avLst/>
          </a:prstGeom>
        </p:spPr>
      </p:pic>
      <p:sp>
        <p:nvSpPr>
          <p:cNvPr id="62" name="文本框 61"/>
          <p:cNvSpPr txBox="1"/>
          <p:nvPr/>
        </p:nvSpPr>
        <p:spPr>
          <a:xfrm>
            <a:off x="333903" y="1499403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4778" y="2803505"/>
            <a:ext cx="2520480" cy="353599"/>
          </a:xfrm>
          <a:prstGeom prst="rect">
            <a:avLst/>
          </a:prstGeom>
        </p:spPr>
      </p:pic>
      <p:sp>
        <p:nvSpPr>
          <p:cNvPr id="63" name="文本框 62"/>
          <p:cNvSpPr txBox="1"/>
          <p:nvPr/>
        </p:nvSpPr>
        <p:spPr>
          <a:xfrm>
            <a:off x="316616" y="3225264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X4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图片 6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3134" y="3194513"/>
            <a:ext cx="2520480" cy="272651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05787" y="1441649"/>
            <a:ext cx="2520000" cy="32665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14030" y="1469888"/>
            <a:ext cx="2520000" cy="320731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862248" y="657649"/>
            <a:ext cx="2628465" cy="1191251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文本框 52"/>
          <p:cNvSpPr txBox="1"/>
          <p:nvPr/>
        </p:nvSpPr>
        <p:spPr>
          <a:xfrm>
            <a:off x="1116399" y="43066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2H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9195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886" r="3003" b="18240"/>
          <a:stretch>
            <a:fillRect/>
          </a:stretch>
        </p:blipFill>
        <p:spPr>
          <a:xfrm>
            <a:off x="699441" y="820493"/>
            <a:ext cx="5040000" cy="416128"/>
          </a:xfrm>
          <a:custGeom>
            <a:avLst/>
            <a:gdLst>
              <a:gd name="connsiteX0" fmla="*/ 0 w 4150468"/>
              <a:gd name="connsiteY0" fmla="*/ 0 h 291829"/>
              <a:gd name="connsiteX1" fmla="*/ 4150468 w 4150468"/>
              <a:gd name="connsiteY1" fmla="*/ 0 h 291829"/>
              <a:gd name="connsiteX2" fmla="*/ 4150468 w 4150468"/>
              <a:gd name="connsiteY2" fmla="*/ 291829 h 291829"/>
              <a:gd name="connsiteX3" fmla="*/ 0 w 4150468"/>
              <a:gd name="connsiteY3" fmla="*/ 291829 h 2918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150468" h="291829">
                <a:moveTo>
                  <a:pt x="0" y="0"/>
                </a:moveTo>
                <a:lnTo>
                  <a:pt x="4150468" y="0"/>
                </a:lnTo>
                <a:lnTo>
                  <a:pt x="4150468" y="291829"/>
                </a:lnTo>
                <a:lnTo>
                  <a:pt x="0" y="291829"/>
                </a:lnTo>
                <a:close/>
              </a:path>
            </a:pathLst>
          </a:cu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314" t="7692" r="422" b="23077"/>
          <a:stretch>
            <a:fillRect/>
          </a:stretch>
        </p:blipFill>
        <p:spPr>
          <a:xfrm>
            <a:off x="699441" y="1235276"/>
            <a:ext cx="5040000" cy="411739"/>
          </a:xfrm>
          <a:custGeom>
            <a:avLst/>
            <a:gdLst>
              <a:gd name="connsiteX0" fmla="*/ 0 w 4286656"/>
              <a:gd name="connsiteY0" fmla="*/ 0 h 350195"/>
              <a:gd name="connsiteX1" fmla="*/ 4286656 w 4286656"/>
              <a:gd name="connsiteY1" fmla="*/ 0 h 350195"/>
              <a:gd name="connsiteX2" fmla="*/ 4286656 w 4286656"/>
              <a:gd name="connsiteY2" fmla="*/ 350195 h 350195"/>
              <a:gd name="connsiteX3" fmla="*/ 0 w 4286656"/>
              <a:gd name="connsiteY3" fmla="*/ 350195 h 35019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286656" h="350195">
                <a:moveTo>
                  <a:pt x="0" y="0"/>
                </a:moveTo>
                <a:lnTo>
                  <a:pt x="4286656" y="0"/>
                </a:lnTo>
                <a:lnTo>
                  <a:pt x="4286656" y="350195"/>
                </a:lnTo>
                <a:lnTo>
                  <a:pt x="0" y="350195"/>
                </a:lnTo>
                <a:close/>
              </a:path>
            </a:pathLst>
          </a:cu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>
            <a:duotone>
              <a:prstClr val="black"/>
              <a:schemeClr val="accent3">
                <a:tint val="45000"/>
                <a:satMod val="400000"/>
              </a:schemeClr>
            </a:duotone>
          </a:blip>
          <a:srcRect l="1288" r="214" b="21404"/>
          <a:stretch>
            <a:fillRect/>
          </a:stretch>
        </p:blipFill>
        <p:spPr>
          <a:xfrm>
            <a:off x="695622" y="2644051"/>
            <a:ext cx="3240000" cy="372893"/>
          </a:xfrm>
          <a:custGeom>
            <a:avLst/>
            <a:gdLst>
              <a:gd name="connsiteX0" fmla="*/ 0 w 2127575"/>
              <a:gd name="connsiteY0" fmla="*/ 0 h 275617"/>
              <a:gd name="connsiteX1" fmla="*/ 2127575 w 2127575"/>
              <a:gd name="connsiteY1" fmla="*/ 0 h 275617"/>
              <a:gd name="connsiteX2" fmla="*/ 2127575 w 2127575"/>
              <a:gd name="connsiteY2" fmla="*/ 275617 h 275617"/>
              <a:gd name="connsiteX3" fmla="*/ 0 w 2127575"/>
              <a:gd name="connsiteY3" fmla="*/ 275617 h 2756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127575" h="275617">
                <a:moveTo>
                  <a:pt x="0" y="0"/>
                </a:moveTo>
                <a:lnTo>
                  <a:pt x="2127575" y="0"/>
                </a:lnTo>
                <a:lnTo>
                  <a:pt x="2127575" y="275617"/>
                </a:lnTo>
                <a:lnTo>
                  <a:pt x="0" y="275617"/>
                </a:lnTo>
                <a:close/>
              </a:path>
            </a:pathLst>
          </a:cu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5">
            <a:duotone>
              <a:prstClr val="black"/>
              <a:schemeClr val="accent3">
                <a:tint val="45000"/>
                <a:satMod val="400000"/>
              </a:schemeClr>
            </a:duotone>
          </a:blip>
          <a:stretch>
            <a:fillRect/>
          </a:stretch>
        </p:blipFill>
        <p:spPr>
          <a:xfrm>
            <a:off x="699441" y="2265211"/>
            <a:ext cx="3240000" cy="375288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076742" y="542948"/>
            <a:ext cx="52149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560950" y="542948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154939" y="542482"/>
            <a:ext cx="49982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620144" y="542948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H="1" flipV="1">
            <a:off x="1166748" y="541986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rot="16200000">
            <a:off x="1468115" y="220765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 flipH="1" flipV="1">
            <a:off x="2217574" y="541519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6200000">
            <a:off x="2606623" y="265179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151104" y="536962"/>
            <a:ext cx="5282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613643" y="536962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207632" y="536496"/>
            <a:ext cx="49982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672837" y="536962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 flipH="1" flipV="1">
            <a:off x="3219441" y="536000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 rot="16200000">
            <a:off x="3520808" y="214779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 flipH="1" flipV="1">
            <a:off x="4270267" y="535533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rot="16200000">
            <a:off x="4659316" y="259193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102091" y="2001620"/>
            <a:ext cx="54512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564629" y="2001620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158617" y="2001154"/>
            <a:ext cx="579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623823" y="2001620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mi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直接连接符 45"/>
          <p:cNvCxnSpPr/>
          <p:nvPr/>
        </p:nvCxnSpPr>
        <p:spPr>
          <a:xfrm flipH="1" flipV="1">
            <a:off x="1170427" y="2000658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 rot="16200000">
            <a:off x="1471794" y="1679437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 flipH="1" flipV="1">
            <a:off x="2221253" y="2000191"/>
            <a:ext cx="947232" cy="4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 rot="16200000">
            <a:off x="2610302" y="1723851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270066" y="873044"/>
            <a:ext cx="550870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270068" y="1267423"/>
            <a:ext cx="499113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70066" y="2337026"/>
            <a:ext cx="550870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270068" y="2731405"/>
            <a:ext cx="499113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/>
          <p:cNvCxnSpPr/>
          <p:nvPr/>
        </p:nvCxnSpPr>
        <p:spPr>
          <a:xfrm>
            <a:off x="1166748" y="363166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3215570" y="373635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1179749" y="1843157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>
            <a:off x="1682509" y="170650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1693992" y="163188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3859530" y="182102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98031" y="816171"/>
            <a:ext cx="2471441" cy="85194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/>
          <p:cNvSpPr txBox="1"/>
          <p:nvPr/>
        </p:nvSpPr>
        <p:spPr>
          <a:xfrm>
            <a:off x="1085999" y="169701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77342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2"/>
          <a:srcRect l="1572" t="17230" r="3818" b="10894"/>
          <a:stretch>
            <a:fillRect/>
          </a:stretch>
        </p:blipFill>
        <p:spPr>
          <a:xfrm>
            <a:off x="764897" y="611919"/>
            <a:ext cx="5040000" cy="368541"/>
          </a:xfrm>
          <a:custGeom>
            <a:avLst/>
            <a:gdLst>
              <a:gd name="connsiteX0" fmla="*/ 0 w 5684578"/>
              <a:gd name="connsiteY0" fmla="*/ 0 h 507614"/>
              <a:gd name="connsiteX1" fmla="*/ 5684578 w 5684578"/>
              <a:gd name="connsiteY1" fmla="*/ 0 h 507614"/>
              <a:gd name="connsiteX2" fmla="*/ 5684578 w 5684578"/>
              <a:gd name="connsiteY2" fmla="*/ 507614 h 507614"/>
              <a:gd name="connsiteX3" fmla="*/ 0 w 5684578"/>
              <a:gd name="connsiteY3" fmla="*/ 507614 h 5076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684578" h="507614">
                <a:moveTo>
                  <a:pt x="0" y="0"/>
                </a:moveTo>
                <a:lnTo>
                  <a:pt x="5684578" y="0"/>
                </a:lnTo>
                <a:lnTo>
                  <a:pt x="5684578" y="507614"/>
                </a:lnTo>
                <a:lnTo>
                  <a:pt x="0" y="507614"/>
                </a:lnTo>
                <a:close/>
              </a:path>
            </a:pathLst>
          </a:cu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3"/>
          <a:srcRect l="1331" t="10524" b="5775"/>
          <a:stretch>
            <a:fillRect/>
          </a:stretch>
        </p:blipFill>
        <p:spPr>
          <a:xfrm>
            <a:off x="764897" y="991467"/>
            <a:ext cx="5040000" cy="372086"/>
          </a:xfrm>
          <a:custGeom>
            <a:avLst/>
            <a:gdLst>
              <a:gd name="connsiteX0" fmla="*/ 0 w 4940542"/>
              <a:gd name="connsiteY0" fmla="*/ 0 h 521521"/>
              <a:gd name="connsiteX1" fmla="*/ 4940542 w 4940542"/>
              <a:gd name="connsiteY1" fmla="*/ 0 h 521521"/>
              <a:gd name="connsiteX2" fmla="*/ 4940542 w 4940542"/>
              <a:gd name="connsiteY2" fmla="*/ 521521 h 521521"/>
              <a:gd name="connsiteX3" fmla="*/ 0 w 4940542"/>
              <a:gd name="connsiteY3" fmla="*/ 521521 h 5215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940542" h="521521">
                <a:moveTo>
                  <a:pt x="0" y="0"/>
                </a:moveTo>
                <a:lnTo>
                  <a:pt x="4940542" y="0"/>
                </a:lnTo>
                <a:lnTo>
                  <a:pt x="4940542" y="521521"/>
                </a:lnTo>
                <a:lnTo>
                  <a:pt x="0" y="521521"/>
                </a:lnTo>
                <a:close/>
              </a:path>
            </a:pathLst>
          </a:custGeom>
        </p:spPr>
      </p:pic>
      <p:sp>
        <p:nvSpPr>
          <p:cNvPr id="19" name="文本框 18"/>
          <p:cNvSpPr txBox="1"/>
          <p:nvPr/>
        </p:nvSpPr>
        <p:spPr>
          <a:xfrm>
            <a:off x="1143812" y="324425"/>
            <a:ext cx="5591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606351" y="324425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200340" y="323959"/>
            <a:ext cx="49982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665545" y="324425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6200000">
            <a:off x="1513516" y="2242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 rot="16200000">
            <a:off x="2652024" y="46656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1221471" y="165962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1735714" y="-45311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197517" y="336658"/>
            <a:ext cx="52722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660056" y="336658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254044" y="336192"/>
            <a:ext cx="57917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719250" y="336658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 rot="16200000">
            <a:off x="3567221" y="14475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 rot="16200000">
            <a:off x="4705729" y="58889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3275176" y="178195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3789419" y="-33078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143813" y="1668129"/>
            <a:ext cx="5591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606351" y="1668129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200339" y="1667663"/>
            <a:ext cx="5791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R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NC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665545" y="1668129"/>
            <a:ext cx="6649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2-5p </a:t>
            </a:r>
          </a:p>
          <a:p>
            <a:pPr algn="ctr"/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 rot="16200000">
            <a:off x="1513516" y="1345946"/>
            <a:ext cx="303481" cy="4761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 rot="16200000">
            <a:off x="2652024" y="1390360"/>
            <a:ext cx="303481" cy="38377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1221471" y="1509666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1735714" y="1298393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18742" y="664877"/>
            <a:ext cx="550870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18744" y="1059256"/>
            <a:ext cx="499113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18742" y="1892517"/>
            <a:ext cx="550870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18744" y="2286896"/>
            <a:ext cx="499113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6" name="图片 55"/>
          <p:cNvPicPr>
            <a:picLocks noChangeAspect="1"/>
          </p:cNvPicPr>
          <p:nvPr/>
        </p:nvPicPr>
        <p:blipFill>
          <a:blip r:embed="rId4"/>
          <a:srcRect l="1912" t="7018" r="2734" b="7374"/>
          <a:stretch>
            <a:fillRect/>
          </a:stretch>
        </p:blipFill>
        <p:spPr>
          <a:xfrm>
            <a:off x="764897" y="2313674"/>
            <a:ext cx="2520000" cy="375145"/>
          </a:xfrm>
          <a:custGeom>
            <a:avLst/>
            <a:gdLst>
              <a:gd name="connsiteX0" fmla="*/ 0 w 3758427"/>
              <a:gd name="connsiteY0" fmla="*/ 0 h 1119532"/>
              <a:gd name="connsiteX1" fmla="*/ 3758427 w 3758427"/>
              <a:gd name="connsiteY1" fmla="*/ 0 h 1119532"/>
              <a:gd name="connsiteX2" fmla="*/ 3758427 w 3758427"/>
              <a:gd name="connsiteY2" fmla="*/ 1119532 h 1119532"/>
              <a:gd name="connsiteX3" fmla="*/ 0 w 3758427"/>
              <a:gd name="connsiteY3" fmla="*/ 1119532 h 11195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758427" h="1119532">
                <a:moveTo>
                  <a:pt x="0" y="0"/>
                </a:moveTo>
                <a:lnTo>
                  <a:pt x="3758427" y="0"/>
                </a:lnTo>
                <a:lnTo>
                  <a:pt x="3758427" y="1119532"/>
                </a:lnTo>
                <a:lnTo>
                  <a:pt x="0" y="1119532"/>
                </a:lnTo>
                <a:close/>
              </a:path>
            </a:pathLst>
          </a:cu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5"/>
          <a:srcRect l="1491" t="7029" r="4158" b="3604"/>
          <a:stretch>
            <a:fillRect/>
          </a:stretch>
        </p:blipFill>
        <p:spPr>
          <a:xfrm>
            <a:off x="764897" y="1957900"/>
            <a:ext cx="2520000" cy="361966"/>
          </a:xfrm>
          <a:custGeom>
            <a:avLst/>
            <a:gdLst>
              <a:gd name="connsiteX0" fmla="*/ 0 w 3313396"/>
              <a:gd name="connsiteY0" fmla="*/ 0 h 942215"/>
              <a:gd name="connsiteX1" fmla="*/ 3313396 w 3313396"/>
              <a:gd name="connsiteY1" fmla="*/ 0 h 942215"/>
              <a:gd name="connsiteX2" fmla="*/ 3313396 w 3313396"/>
              <a:gd name="connsiteY2" fmla="*/ 942215 h 942215"/>
              <a:gd name="connsiteX3" fmla="*/ 0 w 3313396"/>
              <a:gd name="connsiteY3" fmla="*/ 942215 h 942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313396" h="942215">
                <a:moveTo>
                  <a:pt x="0" y="0"/>
                </a:moveTo>
                <a:lnTo>
                  <a:pt x="3313396" y="0"/>
                </a:lnTo>
                <a:lnTo>
                  <a:pt x="3313396" y="942215"/>
                </a:lnTo>
                <a:lnTo>
                  <a:pt x="0" y="942215"/>
                </a:lnTo>
                <a:close/>
              </a:path>
            </a:pathLst>
          </a:custGeom>
        </p:spPr>
      </p:pic>
      <p:sp>
        <p:nvSpPr>
          <p:cNvPr id="3" name="矩形 2"/>
          <p:cNvSpPr/>
          <p:nvPr/>
        </p:nvSpPr>
        <p:spPr>
          <a:xfrm>
            <a:off x="764897" y="587580"/>
            <a:ext cx="2475486" cy="77597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文本框 35"/>
          <p:cNvSpPr txBox="1"/>
          <p:nvPr/>
        </p:nvSpPr>
        <p:spPr>
          <a:xfrm>
            <a:off x="1129848" y="-20921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5G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72761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/>
          <p:cNvGrpSpPr/>
          <p:nvPr/>
        </p:nvGrpSpPr>
        <p:grpSpPr>
          <a:xfrm>
            <a:off x="1795925" y="-23094"/>
            <a:ext cx="2851513" cy="3537961"/>
            <a:chOff x="26331" y="-6648"/>
            <a:chExt cx="2851513" cy="3537961"/>
          </a:xfrm>
        </p:grpSpPr>
        <p:sp>
          <p:nvSpPr>
            <p:cNvPr id="2" name="文本框 1"/>
            <p:cNvSpPr txBox="1"/>
            <p:nvPr/>
          </p:nvSpPr>
          <p:spPr>
            <a:xfrm>
              <a:off x="53278" y="206535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53279" y="690344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53278" y="127142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53278" y="426481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6331" y="2988932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794007" y="179577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4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1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2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2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747958" y="1102151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4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3   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T3               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4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T4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747957" y="1868287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4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5                    T5 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N6                   T6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24932" y="2813018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4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7                    T7                   N8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8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53277" y="1577032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3277" y="2405941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3277" y="3283417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3277" y="-6648"/>
              <a:ext cx="1013353" cy="275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8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1</a:t>
              </a:r>
              <a:endParaRPr lang="zh-CN" altLang="en-US" sz="1188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09430" y="650101"/>
              <a:ext cx="1786437" cy="280067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9431" y="2004320"/>
              <a:ext cx="1786436" cy="286744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9432" y="1537741"/>
              <a:ext cx="1786435" cy="284559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9432" y="2327631"/>
              <a:ext cx="1786435" cy="314849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9432" y="3245452"/>
              <a:ext cx="1786434" cy="285861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0019" y="2946760"/>
              <a:ext cx="1785847" cy="278795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9431" y="1247837"/>
              <a:ext cx="1786436" cy="279889"/>
            </a:xfrm>
            <a:prstGeom prst="rect">
              <a:avLst/>
            </a:prstGeom>
          </p:spPr>
        </p:pic>
      </p:grpSp>
      <p:sp>
        <p:nvSpPr>
          <p:cNvPr id="24" name="矩形 23"/>
          <p:cNvSpPr/>
          <p:nvPr/>
        </p:nvSpPr>
        <p:spPr>
          <a:xfrm>
            <a:off x="1822871" y="52152"/>
            <a:ext cx="2394495" cy="352895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1346821" y="0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6A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73845" y="291337"/>
            <a:ext cx="1786436" cy="324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72215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95574" y="0"/>
            <a:ext cx="2942977" cy="3507519"/>
            <a:chOff x="1584400" y="-5933"/>
            <a:chExt cx="2942977" cy="3507519"/>
          </a:xfrm>
        </p:grpSpPr>
        <p:sp>
          <p:nvSpPr>
            <p:cNvPr id="4" name="文本框 3"/>
            <p:cNvSpPr txBox="1"/>
            <p:nvPr/>
          </p:nvSpPr>
          <p:spPr>
            <a:xfrm>
              <a:off x="1611347" y="197484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611347" y="599834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611347" y="118091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611347" y="335971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584400" y="2898422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411280" y="86919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1 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T1             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2                T2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443540" y="930458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3                    T3                   N4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4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443539" y="1798835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5                    T5                  N6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6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443539" y="2721503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7                    T7                   N8                T8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611346" y="1492568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638292" y="2341518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584400" y="3255302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584400" y="-5933"/>
              <a:ext cx="1013353" cy="275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8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2</a:t>
              </a:r>
              <a:endParaRPr lang="zh-CN" altLang="en-US" sz="1188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84957" y="270883"/>
              <a:ext cx="1785118" cy="286619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84957" y="1096766"/>
              <a:ext cx="1785117" cy="318059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84958" y="1932535"/>
              <a:ext cx="1785116" cy="293306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84957" y="569113"/>
              <a:ext cx="1785118" cy="293098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84958" y="1417925"/>
              <a:ext cx="1785116" cy="276681"/>
            </a:xfrm>
            <a:prstGeom prst="rect">
              <a:avLst/>
            </a:prstGeom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84957" y="2230223"/>
              <a:ext cx="1785117" cy="288712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84956" y="3213201"/>
              <a:ext cx="1785117" cy="288385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84956" y="2889728"/>
              <a:ext cx="1785117" cy="286617"/>
            </a:xfrm>
            <a:prstGeom prst="rect">
              <a:avLst/>
            </a:prstGeom>
          </p:spPr>
        </p:pic>
      </p:grpSp>
      <p:sp>
        <p:nvSpPr>
          <p:cNvPr id="32" name="文本框 31"/>
          <p:cNvSpPr txBox="1"/>
          <p:nvPr/>
        </p:nvSpPr>
        <p:spPr>
          <a:xfrm>
            <a:off x="1321891" y="34817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6A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94183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86367" y="0"/>
            <a:ext cx="2913626" cy="3483380"/>
            <a:chOff x="1584400" y="-18149"/>
            <a:chExt cx="2913626" cy="3483380"/>
          </a:xfrm>
        </p:grpSpPr>
        <p:sp>
          <p:nvSpPr>
            <p:cNvPr id="4" name="文本框 3"/>
            <p:cNvSpPr txBox="1"/>
            <p:nvPr/>
          </p:nvSpPr>
          <p:spPr>
            <a:xfrm>
              <a:off x="1611347" y="197484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611347" y="599834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611347" y="1180918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611347" y="335971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584400" y="2898422"/>
              <a:ext cx="573611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 - actin</a:t>
              </a:r>
              <a:endParaRPr lang="zh-CN" alt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5877" y="580161"/>
              <a:ext cx="1817619" cy="287713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2414189" y="87527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1                    T1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2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2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414188" y="962436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3                    T3                   N4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4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414187" y="1763285"/>
              <a:ext cx="2083837" cy="209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2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5                    T5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6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6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414186" y="2728721"/>
              <a:ext cx="208383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7 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7                  </a:t>
              </a:r>
              <a:r>
                <a:rPr lang="en-US" altLang="zh-CN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</a:t>
              </a:r>
              <a:r>
                <a:rPr lang="en-US" altLang="zh-CN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8                T8</a:t>
              </a:r>
              <a:endParaRPr lang="zh-CN" altLang="en-US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45877" y="1439312"/>
              <a:ext cx="1817619" cy="290723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1611346" y="1492568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638292" y="2341518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584400" y="3255302"/>
              <a:ext cx="519718" cy="2099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64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lang="zh-CN" altLang="en-US" sz="764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45877" y="2219483"/>
              <a:ext cx="1817619" cy="281298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45877" y="2864736"/>
              <a:ext cx="1817619" cy="294995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45877" y="3178537"/>
              <a:ext cx="1817619" cy="286694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>
              <a:off x="1611346" y="-18149"/>
              <a:ext cx="1013353" cy="275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88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3</a:t>
              </a:r>
              <a:endParaRPr lang="zh-CN" altLang="en-US" sz="1188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45877" y="1127164"/>
              <a:ext cx="1817619" cy="292284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45878" y="1919778"/>
              <a:ext cx="1817618" cy="279971"/>
            </a:xfrm>
            <a:prstGeom prst="rect">
              <a:avLst/>
            </a:prstGeom>
          </p:spPr>
        </p:pic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45877" y="270360"/>
              <a:ext cx="1817619" cy="313383"/>
            </a:xfrm>
            <a:prstGeom prst="rect">
              <a:avLst/>
            </a:prstGeom>
          </p:spPr>
        </p:pic>
      </p:grpSp>
      <p:sp>
        <p:nvSpPr>
          <p:cNvPr id="24" name="文本框 23"/>
          <p:cNvSpPr txBox="1"/>
          <p:nvPr/>
        </p:nvSpPr>
        <p:spPr>
          <a:xfrm>
            <a:off x="1321891" y="40831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6A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23982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rcRect l="1415" t="15134" r="2891" b="21951"/>
          <a:stretch>
            <a:fillRect/>
          </a:stretch>
        </p:blipFill>
        <p:spPr>
          <a:xfrm>
            <a:off x="688409" y="726652"/>
            <a:ext cx="5040000" cy="359099"/>
          </a:xfrm>
          <a:custGeom>
            <a:avLst/>
            <a:gdLst>
              <a:gd name="connsiteX0" fmla="*/ 0 w 5820174"/>
              <a:gd name="connsiteY0" fmla="*/ 0 h 563243"/>
              <a:gd name="connsiteX1" fmla="*/ 5820174 w 5820174"/>
              <a:gd name="connsiteY1" fmla="*/ 0 h 563243"/>
              <a:gd name="connsiteX2" fmla="*/ 5820174 w 5820174"/>
              <a:gd name="connsiteY2" fmla="*/ 563243 h 563243"/>
              <a:gd name="connsiteX3" fmla="*/ 0 w 5820174"/>
              <a:gd name="connsiteY3" fmla="*/ 563243 h 56324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820174" h="563243">
                <a:moveTo>
                  <a:pt x="0" y="0"/>
                </a:moveTo>
                <a:lnTo>
                  <a:pt x="5820174" y="0"/>
                </a:lnTo>
                <a:lnTo>
                  <a:pt x="5820174" y="563243"/>
                </a:lnTo>
                <a:lnTo>
                  <a:pt x="0" y="563243"/>
                </a:lnTo>
                <a:close/>
              </a:path>
            </a:pathLst>
          </a:cu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rcRect t="8393" b="20362"/>
          <a:stretch>
            <a:fillRect/>
          </a:stretch>
        </p:blipFill>
        <p:spPr>
          <a:xfrm>
            <a:off x="688409" y="1088377"/>
            <a:ext cx="5040000" cy="358311"/>
          </a:xfrm>
          <a:custGeom>
            <a:avLst/>
            <a:gdLst>
              <a:gd name="connsiteX0" fmla="*/ 0 w 3968293"/>
              <a:gd name="connsiteY0" fmla="*/ 0 h 399833"/>
              <a:gd name="connsiteX1" fmla="*/ 3968293 w 3968293"/>
              <a:gd name="connsiteY1" fmla="*/ 0 h 399833"/>
              <a:gd name="connsiteX2" fmla="*/ 3968293 w 3968293"/>
              <a:gd name="connsiteY2" fmla="*/ 399833 h 399833"/>
              <a:gd name="connsiteX3" fmla="*/ 0 w 3968293"/>
              <a:gd name="connsiteY3" fmla="*/ 399833 h 399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968293" h="399833">
                <a:moveTo>
                  <a:pt x="0" y="0"/>
                </a:moveTo>
                <a:lnTo>
                  <a:pt x="3968293" y="0"/>
                </a:lnTo>
                <a:lnTo>
                  <a:pt x="3968293" y="399833"/>
                </a:lnTo>
                <a:lnTo>
                  <a:pt x="0" y="399833"/>
                </a:lnTo>
                <a:close/>
              </a:path>
            </a:pathLst>
          </a:custGeom>
        </p:spPr>
      </p:pic>
      <p:sp>
        <p:nvSpPr>
          <p:cNvPr id="6" name="文本框 5"/>
          <p:cNvSpPr txBox="1"/>
          <p:nvPr/>
        </p:nvSpPr>
        <p:spPr>
          <a:xfrm>
            <a:off x="261237" y="774288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61237" y="121194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697824" y="545877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177756" y="530769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504045" y="530769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231785" y="554277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698338" y="568861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206040" y="565135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531645" y="580346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225817" y="588543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1168357" y="545877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682600" y="33460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3190743" y="550761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3710894" y="334731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61237" y="1836219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61237" y="223459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4"/>
          <a:srcRect l="1242" t="7372" r="2249" b="5686"/>
          <a:stretch>
            <a:fillRect/>
          </a:stretch>
        </p:blipFill>
        <p:spPr>
          <a:xfrm>
            <a:off x="701886" y="2144996"/>
            <a:ext cx="2520000" cy="359882"/>
          </a:xfrm>
          <a:custGeom>
            <a:avLst/>
            <a:gdLst>
              <a:gd name="connsiteX0" fmla="*/ 0 w 3431608"/>
              <a:gd name="connsiteY0" fmla="*/ 0 h 830957"/>
              <a:gd name="connsiteX1" fmla="*/ 3431608 w 3431608"/>
              <a:gd name="connsiteY1" fmla="*/ 0 h 830957"/>
              <a:gd name="connsiteX2" fmla="*/ 3431608 w 3431608"/>
              <a:gd name="connsiteY2" fmla="*/ 830957 h 830957"/>
              <a:gd name="connsiteX3" fmla="*/ 0 w 3431608"/>
              <a:gd name="connsiteY3" fmla="*/ 830957 h 8309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31608" h="830957">
                <a:moveTo>
                  <a:pt x="0" y="0"/>
                </a:moveTo>
                <a:lnTo>
                  <a:pt x="3431608" y="0"/>
                </a:lnTo>
                <a:lnTo>
                  <a:pt x="3431608" y="830957"/>
                </a:lnTo>
                <a:lnTo>
                  <a:pt x="0" y="830957"/>
                </a:lnTo>
                <a:close/>
              </a:path>
            </a:pathLst>
          </a:custGeom>
        </p:spPr>
      </p:pic>
      <p:cxnSp>
        <p:nvCxnSpPr>
          <p:cNvPr id="24" name="直接连接符 23"/>
          <p:cNvCxnSpPr/>
          <p:nvPr/>
        </p:nvCxnSpPr>
        <p:spPr>
          <a:xfrm>
            <a:off x="265861" y="407433"/>
            <a:ext cx="18509" cy="21095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NE-2Z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1166036" y="1634367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1680279" y="142309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5"/>
          <a:srcRect l="1259" t="2453" r="1279" b="3350"/>
          <a:stretch>
            <a:fillRect/>
          </a:stretch>
        </p:blipFill>
        <p:spPr>
          <a:xfrm>
            <a:off x="701886" y="1784031"/>
            <a:ext cx="2520000" cy="361499"/>
          </a:xfrm>
          <a:custGeom>
            <a:avLst/>
            <a:gdLst>
              <a:gd name="connsiteX0" fmla="*/ 0 w 3709752"/>
              <a:gd name="connsiteY0" fmla="*/ 0 h 910923"/>
              <a:gd name="connsiteX1" fmla="*/ 3709752 w 3709752"/>
              <a:gd name="connsiteY1" fmla="*/ 0 h 910923"/>
              <a:gd name="connsiteX2" fmla="*/ 3709752 w 3709752"/>
              <a:gd name="connsiteY2" fmla="*/ 910923 h 910923"/>
              <a:gd name="connsiteX3" fmla="*/ 0 w 3709752"/>
              <a:gd name="connsiteY3" fmla="*/ 910923 h 91092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709752" h="910923">
                <a:moveTo>
                  <a:pt x="0" y="0"/>
                </a:moveTo>
                <a:lnTo>
                  <a:pt x="3709752" y="0"/>
                </a:lnTo>
                <a:lnTo>
                  <a:pt x="3709752" y="910923"/>
                </a:lnTo>
                <a:lnTo>
                  <a:pt x="0" y="910923"/>
                </a:lnTo>
                <a:close/>
              </a:path>
            </a:pathLst>
          </a:custGeom>
        </p:spPr>
      </p:pic>
      <p:sp>
        <p:nvSpPr>
          <p:cNvPr id="30" name="文本框 29"/>
          <p:cNvSpPr txBox="1"/>
          <p:nvPr/>
        </p:nvSpPr>
        <p:spPr>
          <a:xfrm>
            <a:off x="2661755" y="1632509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171784" y="1625403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498073" y="1625403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213080" y="1638185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93555" y="695541"/>
            <a:ext cx="2461984" cy="768711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1078487" y="354672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7C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3334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61237" y="774288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61237" y="121194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728985" y="539254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177756" y="530769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504045" y="530769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198217" y="526145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672335" y="546971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227102" y="545537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480046" y="544961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185962" y="553146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1168357" y="545877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682600" y="33460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3190743" y="550761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3710894" y="334731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61237" y="1836219"/>
            <a:ext cx="629655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- actin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61237" y="2234596"/>
            <a:ext cx="570496" cy="2111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7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65861" y="407433"/>
            <a:ext cx="18509" cy="21095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10800000">
            <a:off x="33271" y="1272129"/>
            <a:ext cx="303481" cy="52844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72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-10B</a:t>
            </a:r>
            <a:endParaRPr lang="zh-CN" altLang="en-US" sz="77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1166036" y="1634367"/>
            <a:ext cx="1984357" cy="972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1680279" y="1423094"/>
            <a:ext cx="880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637029" y="1610138"/>
            <a:ext cx="5240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altLang="zh-CN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171784" y="1625403"/>
            <a:ext cx="4607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1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498073" y="1625403"/>
            <a:ext cx="69417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-CS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192245" y="1620779"/>
            <a:ext cx="421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2</a:t>
            </a:r>
            <a:endParaRPr lang="zh-CN" altLang="en-US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596" y="699862"/>
            <a:ext cx="5031226" cy="36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2834" y="1062732"/>
            <a:ext cx="5040000" cy="34326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1209" y="1780898"/>
            <a:ext cx="2520000" cy="360084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1209" y="2140982"/>
            <a:ext cx="2520000" cy="363404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711209" y="674500"/>
            <a:ext cx="2439184" cy="78575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1078487" y="354672"/>
            <a:ext cx="5642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7C</a:t>
            </a:r>
            <a:endParaRPr lang="zh-CN" alt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144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9</TotalTime>
  <Words>434</Words>
  <Application>Microsoft Office PowerPoint</Application>
  <PresentationFormat>自定义</PresentationFormat>
  <Paragraphs>264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82</cp:revision>
  <dcterms:created xsi:type="dcterms:W3CDTF">2022-10-18T08:33:48Z</dcterms:created>
  <dcterms:modified xsi:type="dcterms:W3CDTF">2024-03-14T13:44:48Z</dcterms:modified>
</cp:coreProperties>
</file>